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DC3498-5320-4832-881F-882354EBEA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4B1EE5-B779-4991-B639-EC8C202BC2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53FFE-02AB-49EC-85E1-4C2A9837D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CF7B97-E81B-406D-B729-56BEC5793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CB2967-4616-4F83-BB55-D47AAB11E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28159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950A1A-3F6A-41DA-B065-B1D9B73588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EE879F-9F66-46A0-AF9A-CFDE9FEE67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96D9C4-8962-44B4-86F5-C86D987B9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B3539A-79EC-453C-AFBE-A50F9D9D8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F51220-69C8-40DD-8164-2DDCA1570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84052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FED38C-2F53-4630-8099-DC25B8EFFD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56CE4B-A781-4DAB-8EC5-828F2A479C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81761-1223-49F5-9671-A803ADFDA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F59D13-5F2A-4661-BF92-9C11D972E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1EC605-C9C5-42BD-AF7F-A5420F0ED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8387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E034DA-3ADD-4906-8D1F-04FA8028B7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3BF6BF-9F64-4933-9F59-4F0C290FD5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18561B-92C4-40D4-B4B7-152B635F1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0BB21E-C357-4057-9C5B-C2407723F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B2DBE1-5877-4A21-AAE6-CE0A3AACB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77890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40F375-A961-4781-A17C-551F345CE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969C5C-CE18-4451-81AF-FDE382132A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8B1F2A-57BE-4D2D-A526-CC0F5F65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0A1C5A-37C2-45B9-9B4B-918710905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77321C-EDBD-4D29-B562-550CAB00B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34597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A41EF-7845-43B0-AAC5-E587842962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8E6385-6D18-43EA-9F51-725859DE4F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53E209-3C9A-4ED8-A27A-A804CD8478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AA1591-A4AF-4782-BC8B-E2F3460C4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B561B3-2BD2-415C-8754-3B37DA3AD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2F7C6-ECF9-4F37-BB32-29116E988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20156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3DB08-5D28-4423-82C2-2403B263FD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A67DE2-A5F4-467E-8D59-41F19E99C3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7D075E-CD2B-4916-B579-24AB1E6270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2A2F2E-F0C2-4754-A496-6A72F03E1F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F0CA8C-7FB5-4542-9477-2AC2207FD3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778A06-8255-49BD-A280-C96A954F4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5B52DD-8726-4E65-ABFC-0E46E883B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F801BF-2B01-4706-BB36-2E0F89111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83435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DC571-1C06-4E62-A965-FB6EEE12D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BAE7BE-F394-4549-998E-3F23A71036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9D8800-2934-42B1-A60E-F42EE6A00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B1D568-D6D1-4C15-8981-836DBB16F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33842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20AFD68-3239-43BA-93BB-C8D86A44E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29FA2F-F58A-47C3-84A1-2119006B9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852176-4D87-4BBF-98A9-7EE57F700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61969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5BED37-998B-4D73-BDC3-D931F4915F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A3018E-F4B3-401E-AF6D-D3C7CDC293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EBEA27-C7DD-4FFE-92F1-1AD468F41A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772240-5AC6-449A-AB25-BDE633587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D75D5A-3552-412C-8707-4BB636B9C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AA41F8-502E-4BC6-BF2A-436A46508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5843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A1E193-CB06-4E2C-A0E8-95546D646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8BFE83-F637-480C-B1CF-345978613A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33FB00-70D6-45BD-9D14-FC6A99F7F4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F0EA20-31CD-406C-A0F7-B2154F95D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EA9CEA-0651-4BDA-87CC-4A0F8FF59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9BE856-F0DF-414A-8A17-1A068CEAD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48738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182CE6-9D57-4C6A-98C6-444D196A3C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195A13-82A0-47CB-B417-84F3CDEF7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DDD767-C63C-4C47-A3AB-315111FAEE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9F23E3-C2E2-453E-8D9D-D2A0C0B88F02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3ED552-DE50-47EB-82A0-1ABC74EA92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3B3F98-ED01-4138-90B6-08BBB7A47B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52A81-E9EF-4A2F-B67F-B3ACB3DDFAF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17455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7BFF390-4F52-7F30-A288-F35B3F5398F6}"/>
              </a:ext>
            </a:extLst>
          </p:cNvPr>
          <p:cNvSpPr txBox="1"/>
          <p:nvPr/>
        </p:nvSpPr>
        <p:spPr>
          <a:xfrm>
            <a:off x="847725" y="762000"/>
            <a:ext cx="9677400" cy="39669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gend </a:t>
            </a:r>
            <a:r>
              <a:rPr lang="nb-NO" sz="18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nb-NO" sz="18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1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nges in US B-mode and power doppler scores of the joints for each individual in the control and HIIT groups at baseline and 3 months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FIGURE S1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number at the x-axis represents individuals in a descending order according to the baseline value for each variable. In the case of a missing column, it either represents the value 0 or missing for that individual. When representing a missing value, it is noted underneath each chart.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S – ultrasound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D – power doppler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IT - high intensity interval training 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- baseline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M - 3 months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1078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410C0D6-1172-476E-ACF8-26E1F11ED3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701" y="765165"/>
            <a:ext cx="4420217" cy="223868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F842D0E-8B0F-4473-BC1C-009BBDF063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3438" y="784217"/>
            <a:ext cx="4382112" cy="220058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A30F2C1-6C0D-41A4-82C2-A3B13F19AC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2806" y="3429000"/>
            <a:ext cx="4382112" cy="221963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763FE4A-7DA0-4674-89BC-9C9F175359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675" y="3429000"/>
            <a:ext cx="4391638" cy="2248214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72CE3F3-E9A6-4780-9DFB-B7CFF84EE1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59776" y="2948178"/>
            <a:ext cx="2956816" cy="26824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5F59716-8615-4C70-84ED-D5DC445237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51898" y="5648635"/>
            <a:ext cx="2499577" cy="31092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A130B07-8C45-4A70-8369-29775447485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08984" y="2981740"/>
            <a:ext cx="2280102" cy="27434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6D7B166-FEA7-43D1-B4E0-403CE91577E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69149" y="5636442"/>
            <a:ext cx="2548349" cy="3231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3573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th Stoklund Thomsen</dc:creator>
  <cp:lastModifiedBy>Ruth Stoklund Thomsen</cp:lastModifiedBy>
  <cp:revision>12</cp:revision>
  <dcterms:created xsi:type="dcterms:W3CDTF">2022-05-23T11:36:12Z</dcterms:created>
  <dcterms:modified xsi:type="dcterms:W3CDTF">2023-04-06T11:48:16Z</dcterms:modified>
</cp:coreProperties>
</file>